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0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200" y="4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7659D-8A77-46DD-83B5-0D9762928F9C}" type="datetimeFigureOut">
              <a:rPr lang="en-US" smtClean="0"/>
              <a:t>8/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C2633-7458-44CF-AE79-789A5539D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8610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7659D-8A77-46DD-83B5-0D9762928F9C}" type="datetimeFigureOut">
              <a:rPr lang="en-US" smtClean="0"/>
              <a:t>8/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C2633-7458-44CF-AE79-789A5539D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7100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7659D-8A77-46DD-83B5-0D9762928F9C}" type="datetimeFigureOut">
              <a:rPr lang="en-US" smtClean="0"/>
              <a:t>8/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C2633-7458-44CF-AE79-789A5539D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2507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7659D-8A77-46DD-83B5-0D9762928F9C}" type="datetimeFigureOut">
              <a:rPr lang="en-US" smtClean="0"/>
              <a:t>8/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C2633-7458-44CF-AE79-789A5539D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0393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7659D-8A77-46DD-83B5-0D9762928F9C}" type="datetimeFigureOut">
              <a:rPr lang="en-US" smtClean="0"/>
              <a:t>8/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C2633-7458-44CF-AE79-789A5539D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853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7659D-8A77-46DD-83B5-0D9762928F9C}" type="datetimeFigureOut">
              <a:rPr lang="en-US" smtClean="0"/>
              <a:t>8/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C2633-7458-44CF-AE79-789A5539D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726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7659D-8A77-46DD-83B5-0D9762928F9C}" type="datetimeFigureOut">
              <a:rPr lang="en-US" smtClean="0"/>
              <a:t>8/3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C2633-7458-44CF-AE79-789A5539D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20644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7659D-8A77-46DD-83B5-0D9762928F9C}" type="datetimeFigureOut">
              <a:rPr lang="en-US" smtClean="0"/>
              <a:t>8/3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C2633-7458-44CF-AE79-789A5539D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43457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7659D-8A77-46DD-83B5-0D9762928F9C}" type="datetimeFigureOut">
              <a:rPr lang="en-US" smtClean="0"/>
              <a:t>8/3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C2633-7458-44CF-AE79-789A5539D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4910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7659D-8A77-46DD-83B5-0D9762928F9C}" type="datetimeFigureOut">
              <a:rPr lang="en-US" smtClean="0"/>
              <a:t>8/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C2633-7458-44CF-AE79-789A5539D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18457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7659D-8A77-46DD-83B5-0D9762928F9C}" type="datetimeFigureOut">
              <a:rPr lang="en-US" smtClean="0"/>
              <a:t>8/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C2633-7458-44CF-AE79-789A5539D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2343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27659D-8A77-46DD-83B5-0D9762928F9C}" type="datetimeFigureOut">
              <a:rPr lang="en-US" smtClean="0"/>
              <a:t>8/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EC2633-7458-44CF-AE79-789A5539D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9467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64" t="33270" r="28971" b="20762"/>
          <a:stretch/>
        </p:blipFill>
        <p:spPr>
          <a:xfrm>
            <a:off x="3641485" y="4313215"/>
            <a:ext cx="2393556" cy="2043555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1325379" y="4065262"/>
            <a:ext cx="7202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/>
              <a:t>OxLDL</a:t>
            </a:r>
            <a:endParaRPr lang="en-US" sz="16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4203038" y="4030426"/>
            <a:ext cx="16096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OxLDL+pNaKtide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28337" y="104251"/>
            <a:ext cx="90511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resentative images showing spectrum obtained after extraction using exosome isolation kit</a:t>
            </a:r>
          </a:p>
        </p:txBody>
      </p:sp>
      <p:pic>
        <p:nvPicPr>
          <p:cNvPr id="29" name="Picture 2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6626" y="1260506"/>
            <a:ext cx="2783211" cy="2237378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1327807" y="1091228"/>
            <a:ext cx="81503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Control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4512884" y="1091228"/>
            <a:ext cx="9714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pNaKtide</a:t>
            </a:r>
          </a:p>
        </p:txBody>
      </p:sp>
      <p:sp>
        <p:nvSpPr>
          <p:cNvPr id="32" name="Rectangle 31"/>
          <p:cNvSpPr/>
          <p:nvPr/>
        </p:nvSpPr>
        <p:spPr>
          <a:xfrm>
            <a:off x="3481552" y="1393748"/>
            <a:ext cx="150148" cy="16927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/>
          <p:cNvSpPr/>
          <p:nvPr/>
        </p:nvSpPr>
        <p:spPr>
          <a:xfrm>
            <a:off x="462188" y="1563025"/>
            <a:ext cx="209744" cy="13285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4" name="Picture 3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146" y="1505643"/>
            <a:ext cx="2737341" cy="198746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76" t="32000" r="26220" b="21143"/>
          <a:stretch/>
        </p:blipFill>
        <p:spPr>
          <a:xfrm>
            <a:off x="380470" y="4337860"/>
            <a:ext cx="2430556" cy="20717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52203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0</TotalTime>
  <Words>17</Words>
  <Application>Microsoft Macintosh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illai, Sneha</dc:creator>
  <cp:lastModifiedBy>Sodhi, Komal</cp:lastModifiedBy>
  <cp:revision>26</cp:revision>
  <dcterms:created xsi:type="dcterms:W3CDTF">2019-10-31T15:30:06Z</dcterms:created>
  <dcterms:modified xsi:type="dcterms:W3CDTF">2022-08-04T00:29:39Z</dcterms:modified>
</cp:coreProperties>
</file>